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5E66690B-A90B-4486-AB1F-5B5666966EAD}" type="slidenum">
              <a:t>&lt;#&gt;</a:t>
            </a:fld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77724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" name="PlaceHolder 3"/>
          <p:cNvSpPr>
            <a:spLocks noGrp="1"/>
          </p:cNvSpPr>
          <p:nvPr>
            <p:ph/>
          </p:nvPr>
        </p:nvSpPr>
        <p:spPr>
          <a:xfrm>
            <a:off x="685800" y="4528080"/>
            <a:ext cx="77724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00C50035-6181-47AD-8F09-88B664EF1896}" type="slidenum">
              <a:t>&lt;#&gt;</a:t>
            </a:fld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3"/>
          <p:cNvSpPr>
            <a:spLocks noGrp="1"/>
          </p:cNvSpPr>
          <p:nvPr>
            <p:ph/>
          </p:nvPr>
        </p:nvSpPr>
        <p:spPr>
          <a:xfrm>
            <a:off x="4668480" y="198072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4"/>
          <p:cNvSpPr>
            <a:spLocks noGrp="1"/>
          </p:cNvSpPr>
          <p:nvPr>
            <p:ph/>
          </p:nvPr>
        </p:nvSpPr>
        <p:spPr>
          <a:xfrm>
            <a:off x="685800" y="452808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5"/>
          <p:cNvSpPr>
            <a:spLocks noGrp="1"/>
          </p:cNvSpPr>
          <p:nvPr>
            <p:ph/>
          </p:nvPr>
        </p:nvSpPr>
        <p:spPr>
          <a:xfrm>
            <a:off x="4668480" y="452808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5D871233-C5CC-454C-BB66-444427A6FF9D}" type="slidenum">
              <a:t>&lt;#&gt;</a:t>
            </a:fld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250236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3"/>
          <p:cNvSpPr>
            <a:spLocks noGrp="1"/>
          </p:cNvSpPr>
          <p:nvPr>
            <p:ph/>
          </p:nvPr>
        </p:nvSpPr>
        <p:spPr>
          <a:xfrm>
            <a:off x="3313800" y="1980720"/>
            <a:ext cx="250236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4"/>
          <p:cNvSpPr>
            <a:spLocks noGrp="1"/>
          </p:cNvSpPr>
          <p:nvPr>
            <p:ph/>
          </p:nvPr>
        </p:nvSpPr>
        <p:spPr>
          <a:xfrm>
            <a:off x="5941440" y="1980720"/>
            <a:ext cx="250236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5"/>
          <p:cNvSpPr>
            <a:spLocks noGrp="1"/>
          </p:cNvSpPr>
          <p:nvPr>
            <p:ph/>
          </p:nvPr>
        </p:nvSpPr>
        <p:spPr>
          <a:xfrm>
            <a:off x="685800" y="4528080"/>
            <a:ext cx="250236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6"/>
          <p:cNvSpPr>
            <a:spLocks noGrp="1"/>
          </p:cNvSpPr>
          <p:nvPr>
            <p:ph/>
          </p:nvPr>
        </p:nvSpPr>
        <p:spPr>
          <a:xfrm>
            <a:off x="3313800" y="4528080"/>
            <a:ext cx="250236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7"/>
          <p:cNvSpPr>
            <a:spLocks noGrp="1"/>
          </p:cNvSpPr>
          <p:nvPr>
            <p:ph/>
          </p:nvPr>
        </p:nvSpPr>
        <p:spPr>
          <a:xfrm>
            <a:off x="5941440" y="4528080"/>
            <a:ext cx="250236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93A14D89-765A-426E-BED7-B09846B64C12}" type="slidenum">
              <a:t>&lt;#&gt;</a:t>
            </a:fld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2"/>
          <p:cNvSpPr>
            <a:spLocks noGrp="1"/>
          </p:cNvSpPr>
          <p:nvPr>
            <p:ph type="subTitle"/>
          </p:nvPr>
        </p:nvSpPr>
        <p:spPr>
          <a:xfrm>
            <a:off x="685800" y="1980720"/>
            <a:ext cx="7772400" cy="4876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9600"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DA1D763A-805C-4628-85F0-FB1B11505D94}" type="slidenum">
              <a:t>&lt;#&gt;</a:t>
            </a:fld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7772400" cy="487692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110468D5-F9BA-424B-B312-787CD22BD6C3}" type="slidenum">
              <a:t>&lt;#&gt;</a:t>
            </a:fld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3792600" cy="487692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3"/>
          <p:cNvSpPr>
            <a:spLocks noGrp="1"/>
          </p:cNvSpPr>
          <p:nvPr>
            <p:ph/>
          </p:nvPr>
        </p:nvSpPr>
        <p:spPr>
          <a:xfrm>
            <a:off x="4668480" y="1980720"/>
            <a:ext cx="3792600" cy="487692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9AC0D7F8-37D1-43B8-A390-38F02F457889}" type="slidenum">
              <a:t>&lt;#&gt;</a:t>
            </a:fld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759F7AD4-0F58-4E15-81AF-EEEFD7991DAE}" type="slidenum">
              <a:t>&lt;#&gt;</a:t>
            </a:fld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subTitle"/>
          </p:nvPr>
        </p:nvSpPr>
        <p:spPr>
          <a:xfrm>
            <a:off x="685800" y="380520"/>
            <a:ext cx="7772400" cy="7418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9600" algn="ctr">
              <a:spcBef>
                <a:spcPts val="7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D2547B0D-6831-4EBA-8999-8BFFB68C6D98}" type="slidenum">
              <a:t>&lt;#&gt;</a:t>
            </a:fld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" name="PlaceHolder 3"/>
          <p:cNvSpPr>
            <a:spLocks noGrp="1"/>
          </p:cNvSpPr>
          <p:nvPr>
            <p:ph/>
          </p:nvPr>
        </p:nvSpPr>
        <p:spPr>
          <a:xfrm>
            <a:off x="4668480" y="1980720"/>
            <a:ext cx="3792600" cy="487692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4"/>
          <p:cNvSpPr>
            <a:spLocks noGrp="1"/>
          </p:cNvSpPr>
          <p:nvPr>
            <p:ph/>
          </p:nvPr>
        </p:nvSpPr>
        <p:spPr>
          <a:xfrm>
            <a:off x="685800" y="452808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8B06BDE8-59FF-4752-8782-A5E8D5F84119}" type="slidenum">
              <a:t>&lt;#&gt;</a:t>
            </a:fld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3792600" cy="487692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3"/>
          <p:cNvSpPr>
            <a:spLocks noGrp="1"/>
          </p:cNvSpPr>
          <p:nvPr>
            <p:ph/>
          </p:nvPr>
        </p:nvSpPr>
        <p:spPr>
          <a:xfrm>
            <a:off x="4668480" y="198072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4"/>
          <p:cNvSpPr>
            <a:spLocks noGrp="1"/>
          </p:cNvSpPr>
          <p:nvPr>
            <p:ph/>
          </p:nvPr>
        </p:nvSpPr>
        <p:spPr>
          <a:xfrm>
            <a:off x="4668480" y="452808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859DADD1-5C27-43D8-9CDF-D2417FCD9923}" type="slidenum">
              <a:t>&lt;#&gt;</a:t>
            </a:fld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2"/>
          <p:cNvSpPr>
            <a:spLocks noGrp="1"/>
          </p:cNvSpPr>
          <p:nvPr>
            <p:ph/>
          </p:nvPr>
        </p:nvSpPr>
        <p:spPr>
          <a:xfrm>
            <a:off x="685800" y="198072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3"/>
          <p:cNvSpPr>
            <a:spLocks noGrp="1"/>
          </p:cNvSpPr>
          <p:nvPr>
            <p:ph/>
          </p:nvPr>
        </p:nvSpPr>
        <p:spPr>
          <a:xfrm>
            <a:off x="4668480" y="1980720"/>
            <a:ext cx="37926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4"/>
          <p:cNvSpPr>
            <a:spLocks noGrp="1"/>
          </p:cNvSpPr>
          <p:nvPr>
            <p:ph/>
          </p:nvPr>
        </p:nvSpPr>
        <p:spPr>
          <a:xfrm>
            <a:off x="685800" y="4528080"/>
            <a:ext cx="7772400" cy="232596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76904D3E-3D0D-4784-A4A8-41EAF649878E}" type="slidenum">
              <a:t>&lt;#&gt;</a:t>
            </a:fld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60020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ctr">
            <a:noAutofit/>
          </a:bodyPr>
          <a:p>
            <a:pPr marL="396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0720"/>
            <a:ext cx="7772400" cy="4876920"/>
          </a:xfrm>
          <a:prstGeom prst="rect">
            <a:avLst/>
          </a:prstGeom>
          <a:noFill/>
          <a:ln w="0">
            <a:noFill/>
          </a:ln>
        </p:spPr>
        <p:txBody>
          <a:bodyPr lIns="50760" rIns="90000" tIns="50760" bIns="50760" anchor="t">
            <a:normAutofit/>
          </a:bodyPr>
          <a:p>
            <a:pPr marL="382680" indent="-34308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1880" indent="-28584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840" indent="-22860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9040" indent="-22860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46240" indent="-22860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46240" indent="-22860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46240" indent="-22860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sldNum" idx="1"/>
          </p:nvPr>
        </p:nvSpPr>
        <p:spPr>
          <a:xfrm>
            <a:off x="7348680" y="6248520"/>
            <a:ext cx="312480" cy="304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 anchorCtr="1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  <a:ea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EEA7B3C-B569-4AD2-AE48-39C7EB6B6940}" type="slidenum"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" name="Picture 5" descr=""/>
          <p:cNvPicPr/>
          <p:nvPr/>
        </p:nvPicPr>
        <p:blipFill>
          <a:blip r:embed="rId1"/>
          <a:srcRect l="8510" t="7859" r="0" b="36112"/>
          <a:stretch/>
        </p:blipFill>
        <p:spPr>
          <a:xfrm>
            <a:off x="685800" y="3429000"/>
            <a:ext cx="6572160" cy="2819520"/>
          </a:xfrm>
          <a:prstGeom prst="rect">
            <a:avLst/>
          </a:prstGeom>
          <a:ln w="0">
            <a:noFill/>
          </a:ln>
        </p:spPr>
      </p:pic>
      <p:sp>
        <p:nvSpPr>
          <p:cNvPr id="40" name="Rectangle 6"/>
          <p:cNvSpPr/>
          <p:nvPr/>
        </p:nvSpPr>
        <p:spPr>
          <a:xfrm>
            <a:off x="609480" y="3505320"/>
            <a:ext cx="67392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a1     a2     BC094279    NM175261        a3    a5   a6         a7         a9            a10         a11                 a13   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1" name="Group 67"/>
          <p:cNvGrpSpPr/>
          <p:nvPr/>
        </p:nvGrpSpPr>
        <p:grpSpPr>
          <a:xfrm>
            <a:off x="788760" y="3809520"/>
            <a:ext cx="6374880" cy="57240"/>
            <a:chOff x="788760" y="3809520"/>
            <a:chExt cx="6374880" cy="57240"/>
          </a:xfrm>
        </p:grpSpPr>
        <p:sp>
          <p:nvSpPr>
            <p:cNvPr id="42" name="Line 7"/>
            <p:cNvSpPr/>
            <p:nvPr/>
          </p:nvSpPr>
          <p:spPr>
            <a:xfrm flipV="1">
              <a:off x="919080" y="3809520"/>
              <a:ext cx="1080" cy="57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Line 8"/>
            <p:cNvSpPr/>
            <p:nvPr/>
          </p:nvSpPr>
          <p:spPr>
            <a:xfrm flipH="1">
              <a:off x="788760" y="3809880"/>
              <a:ext cx="13068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Line 9"/>
            <p:cNvSpPr/>
            <p:nvPr/>
          </p:nvSpPr>
          <p:spPr>
            <a:xfrm flipV="1">
              <a:off x="1308960" y="3809520"/>
              <a:ext cx="1080" cy="57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Line 10"/>
            <p:cNvSpPr/>
            <p:nvPr/>
          </p:nvSpPr>
          <p:spPr>
            <a:xfrm flipH="1">
              <a:off x="1178640" y="3809880"/>
              <a:ext cx="13068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Line 11"/>
            <p:cNvSpPr/>
            <p:nvPr/>
          </p:nvSpPr>
          <p:spPr>
            <a:xfrm flipV="1">
              <a:off x="2935800" y="3809520"/>
              <a:ext cx="1080" cy="57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Line 12"/>
            <p:cNvSpPr/>
            <p:nvPr/>
          </p:nvSpPr>
          <p:spPr>
            <a:xfrm flipH="1">
              <a:off x="2805120" y="3809880"/>
              <a:ext cx="13068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Line 13"/>
            <p:cNvSpPr/>
            <p:nvPr/>
          </p:nvSpPr>
          <p:spPr>
            <a:xfrm flipV="1">
              <a:off x="3520440" y="3809520"/>
              <a:ext cx="1080" cy="57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Line 14"/>
            <p:cNvSpPr/>
            <p:nvPr/>
          </p:nvSpPr>
          <p:spPr>
            <a:xfrm flipH="1">
              <a:off x="3390120" y="3809880"/>
              <a:ext cx="13068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Line 15"/>
            <p:cNvSpPr/>
            <p:nvPr/>
          </p:nvSpPr>
          <p:spPr>
            <a:xfrm flipV="1">
              <a:off x="3715560" y="3809520"/>
              <a:ext cx="1080" cy="57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Line 16"/>
            <p:cNvSpPr/>
            <p:nvPr/>
          </p:nvSpPr>
          <p:spPr>
            <a:xfrm flipH="1">
              <a:off x="3586320" y="3809880"/>
              <a:ext cx="12924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Line 17"/>
            <p:cNvSpPr/>
            <p:nvPr/>
          </p:nvSpPr>
          <p:spPr>
            <a:xfrm flipV="1">
              <a:off x="3976200" y="3809520"/>
              <a:ext cx="1080" cy="57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Line 18"/>
            <p:cNvSpPr/>
            <p:nvPr/>
          </p:nvSpPr>
          <p:spPr>
            <a:xfrm flipH="1">
              <a:off x="3845520" y="3809880"/>
              <a:ext cx="13068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Line 19"/>
            <p:cNvSpPr/>
            <p:nvPr/>
          </p:nvSpPr>
          <p:spPr>
            <a:xfrm flipV="1">
              <a:off x="4495320" y="3809520"/>
              <a:ext cx="1080" cy="57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Line 20"/>
            <p:cNvSpPr/>
            <p:nvPr/>
          </p:nvSpPr>
          <p:spPr>
            <a:xfrm flipH="1">
              <a:off x="4366440" y="3809880"/>
              <a:ext cx="12924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Line 21"/>
            <p:cNvSpPr/>
            <p:nvPr/>
          </p:nvSpPr>
          <p:spPr>
            <a:xfrm flipV="1">
              <a:off x="4560840" y="3809520"/>
              <a:ext cx="1080" cy="57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Line 22"/>
            <p:cNvSpPr/>
            <p:nvPr/>
          </p:nvSpPr>
          <p:spPr>
            <a:xfrm flipH="1">
              <a:off x="4431600" y="3809880"/>
              <a:ext cx="12924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Line 23"/>
            <p:cNvSpPr/>
            <p:nvPr/>
          </p:nvSpPr>
          <p:spPr>
            <a:xfrm flipV="1">
              <a:off x="4691880" y="3809520"/>
              <a:ext cx="1080" cy="57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Line 24"/>
            <p:cNvSpPr/>
            <p:nvPr/>
          </p:nvSpPr>
          <p:spPr>
            <a:xfrm flipH="1">
              <a:off x="4561200" y="3809880"/>
              <a:ext cx="13068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Line 25"/>
            <p:cNvSpPr/>
            <p:nvPr/>
          </p:nvSpPr>
          <p:spPr>
            <a:xfrm flipV="1">
              <a:off x="5016240" y="3809520"/>
              <a:ext cx="1080" cy="57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Line 26"/>
            <p:cNvSpPr/>
            <p:nvPr/>
          </p:nvSpPr>
          <p:spPr>
            <a:xfrm flipH="1">
              <a:off x="4887000" y="3809880"/>
              <a:ext cx="12924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27"/>
            <p:cNvSpPr/>
            <p:nvPr/>
          </p:nvSpPr>
          <p:spPr>
            <a:xfrm flipV="1">
              <a:off x="5147280" y="3809520"/>
              <a:ext cx="1080" cy="57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28"/>
            <p:cNvSpPr/>
            <p:nvPr/>
          </p:nvSpPr>
          <p:spPr>
            <a:xfrm flipH="1">
              <a:off x="5016600" y="3809880"/>
              <a:ext cx="13068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29"/>
            <p:cNvSpPr/>
            <p:nvPr/>
          </p:nvSpPr>
          <p:spPr>
            <a:xfrm flipV="1">
              <a:off x="5601240" y="3809520"/>
              <a:ext cx="1080" cy="57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Line 30"/>
            <p:cNvSpPr/>
            <p:nvPr/>
          </p:nvSpPr>
          <p:spPr>
            <a:xfrm flipH="1">
              <a:off x="5472000" y="3809880"/>
              <a:ext cx="12924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31"/>
            <p:cNvSpPr/>
            <p:nvPr/>
          </p:nvSpPr>
          <p:spPr>
            <a:xfrm flipV="1">
              <a:off x="6252840" y="3809520"/>
              <a:ext cx="1080" cy="57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Line 32"/>
            <p:cNvSpPr/>
            <p:nvPr/>
          </p:nvSpPr>
          <p:spPr>
            <a:xfrm flipH="1">
              <a:off x="6122520" y="3809880"/>
              <a:ext cx="13068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Line 33"/>
            <p:cNvSpPr/>
            <p:nvPr/>
          </p:nvSpPr>
          <p:spPr>
            <a:xfrm flipV="1">
              <a:off x="7162560" y="3809520"/>
              <a:ext cx="1080" cy="57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Line 34"/>
            <p:cNvSpPr/>
            <p:nvPr/>
          </p:nvSpPr>
          <p:spPr>
            <a:xfrm flipH="1">
              <a:off x="7033320" y="3809880"/>
              <a:ext cx="12924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Line 35"/>
            <p:cNvSpPr/>
            <p:nvPr/>
          </p:nvSpPr>
          <p:spPr>
            <a:xfrm flipV="1">
              <a:off x="1569600" y="3809520"/>
              <a:ext cx="1080" cy="57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Line 36"/>
            <p:cNvSpPr/>
            <p:nvPr/>
          </p:nvSpPr>
          <p:spPr>
            <a:xfrm>
              <a:off x="1570320" y="3809880"/>
              <a:ext cx="12924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Line 37"/>
            <p:cNvSpPr/>
            <p:nvPr/>
          </p:nvSpPr>
          <p:spPr>
            <a:xfrm flipV="1">
              <a:off x="2089080" y="3809520"/>
              <a:ext cx="1080" cy="57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Line 38"/>
            <p:cNvSpPr/>
            <p:nvPr/>
          </p:nvSpPr>
          <p:spPr>
            <a:xfrm>
              <a:off x="2089800" y="3809880"/>
              <a:ext cx="13068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4" name="Rectangle 42"/>
          <p:cNvSpPr/>
          <p:nvPr/>
        </p:nvSpPr>
        <p:spPr>
          <a:xfrm>
            <a:off x="1219320" y="152280"/>
            <a:ext cx="5333760" cy="425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40680" tIns="0" bIns="0" anchor="t">
            <a:noAutofit/>
          </a:bodyPr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dditional file </a:t>
            </a: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. T-DMRs within the Hoxa gene cluster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44"/>
          <p:cNvSpPr/>
          <p:nvPr/>
        </p:nvSpPr>
        <p:spPr>
          <a:xfrm>
            <a:off x="7374960" y="3352680"/>
            <a:ext cx="9129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pG island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45"/>
          <p:cNvSpPr/>
          <p:nvPr/>
        </p:nvSpPr>
        <p:spPr>
          <a:xfrm>
            <a:off x="7337160" y="3581280"/>
            <a:ext cx="835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ranscrip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46"/>
          <p:cNvSpPr/>
          <p:nvPr/>
        </p:nvSpPr>
        <p:spPr>
          <a:xfrm>
            <a:off x="7499880" y="4343400"/>
            <a:ext cx="4118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Liv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49"/>
          <p:cNvSpPr/>
          <p:nvPr/>
        </p:nvSpPr>
        <p:spPr>
          <a:xfrm>
            <a:off x="7525080" y="4800600"/>
            <a:ext cx="4377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ra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54"/>
          <p:cNvSpPr/>
          <p:nvPr/>
        </p:nvSpPr>
        <p:spPr>
          <a:xfrm>
            <a:off x="7525440" y="5378400"/>
            <a:ext cx="454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40680" tIns="0" bIns="0" anchor="t">
            <a:spAutoFit/>
          </a:bodyPr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Hear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56"/>
          <p:cNvSpPr/>
          <p:nvPr/>
        </p:nvSpPr>
        <p:spPr>
          <a:xfrm>
            <a:off x="7303680" y="3762360"/>
            <a:ext cx="1683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ヒラギノ角ゴ ProN W3"/>
              </a:rPr>
              <a:t>Transcription direc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Freeform 57"/>
          <p:cNvSpPr/>
          <p:nvPr/>
        </p:nvSpPr>
        <p:spPr>
          <a:xfrm>
            <a:off x="7391520" y="4832280"/>
            <a:ext cx="75960" cy="152640"/>
          </a:xfrm>
          <a:custGeom>
            <a:avLst/>
            <a:gdLst>
              <a:gd name="textAreaLeft" fmla="*/ 0 w 75960"/>
              <a:gd name="textAreaRight" fmla="*/ 76320 w 75960"/>
              <a:gd name="textAreaTop" fmla="*/ 0 h 152640"/>
              <a:gd name="textAreaBottom" fmla="*/ 153000 h 1526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1929" y="0"/>
                  <a:pt x="21600" y="806"/>
                  <a:pt x="21600" y="1800"/>
                </a:cubicBezTo>
                <a:lnTo>
                  <a:pt x="21600" y="19800"/>
                </a:lnTo>
                <a:cubicBezTo>
                  <a:pt x="21600" y="20794"/>
                  <a:pt x="11929" y="21600"/>
                  <a:pt x="0" y="21600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Freeform 58"/>
          <p:cNvSpPr/>
          <p:nvPr/>
        </p:nvSpPr>
        <p:spPr>
          <a:xfrm>
            <a:off x="7391520" y="4343400"/>
            <a:ext cx="75960" cy="152280"/>
          </a:xfrm>
          <a:custGeom>
            <a:avLst/>
            <a:gdLst>
              <a:gd name="textAreaLeft" fmla="*/ 0 w 75960"/>
              <a:gd name="textAreaRight" fmla="*/ 76320 w 75960"/>
              <a:gd name="textAreaTop" fmla="*/ 0 h 152280"/>
              <a:gd name="textAreaBottom" fmla="*/ 152640 h 1522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1929" y="0"/>
                  <a:pt x="21600" y="806"/>
                  <a:pt x="21600" y="1800"/>
                </a:cubicBezTo>
                <a:lnTo>
                  <a:pt x="21600" y="19800"/>
                </a:lnTo>
                <a:cubicBezTo>
                  <a:pt x="21600" y="20794"/>
                  <a:pt x="11929" y="21600"/>
                  <a:pt x="0" y="21600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3" name="Picture 59" descr=""/>
          <p:cNvPicPr/>
          <p:nvPr/>
        </p:nvPicPr>
        <p:blipFill>
          <a:blip r:embed="rId2"/>
          <a:srcRect l="1102" t="0" r="0" b="0"/>
          <a:stretch/>
        </p:blipFill>
        <p:spPr>
          <a:xfrm>
            <a:off x="304920" y="685800"/>
            <a:ext cx="6846840" cy="2590920"/>
          </a:xfrm>
          <a:prstGeom prst="rect">
            <a:avLst/>
          </a:prstGeom>
          <a:ln w="0">
            <a:noFill/>
          </a:ln>
        </p:spPr>
      </p:pic>
      <p:sp>
        <p:nvSpPr>
          <p:cNvPr id="84" name="Line 60"/>
          <p:cNvSpPr/>
          <p:nvPr/>
        </p:nvSpPr>
        <p:spPr>
          <a:xfrm flipH="1">
            <a:off x="838080" y="1600200"/>
            <a:ext cx="1447920" cy="1828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Line 61"/>
          <p:cNvSpPr/>
          <p:nvPr/>
        </p:nvSpPr>
        <p:spPr>
          <a:xfrm>
            <a:off x="6934320" y="3048120"/>
            <a:ext cx="152280" cy="457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6" name="Group 66"/>
          <p:cNvGrpSpPr/>
          <p:nvPr/>
        </p:nvGrpSpPr>
        <p:grpSpPr>
          <a:xfrm>
            <a:off x="1468080" y="6194520"/>
            <a:ext cx="5787360" cy="204840"/>
            <a:chOff x="1468080" y="6194520"/>
            <a:chExt cx="5787360" cy="204840"/>
          </a:xfrm>
        </p:grpSpPr>
        <p:sp>
          <p:nvSpPr>
            <p:cNvPr id="87" name="Rectangle 41"/>
            <p:cNvSpPr/>
            <p:nvPr/>
          </p:nvSpPr>
          <p:spPr>
            <a:xfrm>
              <a:off x="1468080" y="6216480"/>
              <a:ext cx="3750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40680" tIns="0" bIns="0" anchor="t">
              <a:spAutoFit/>
            </a:bodyPr>
            <a:p>
              <a:pPr marL="39600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1         2                   3  4    5     6                7    8          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Rectangle 43"/>
            <p:cNvSpPr/>
            <p:nvPr/>
          </p:nvSpPr>
          <p:spPr>
            <a:xfrm>
              <a:off x="5373000" y="6194520"/>
              <a:ext cx="18824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40680" tIns="0" bIns="0" anchor="t">
              <a:spAutoFit/>
            </a:bodyPr>
            <a:p>
              <a:pPr marL="39600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Methylation Peak Number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9" name="Rectangle 47"/>
          <p:cNvSpPr/>
          <p:nvPr/>
        </p:nvSpPr>
        <p:spPr>
          <a:xfrm>
            <a:off x="7543800" y="5867280"/>
            <a:ext cx="533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40680" tIns="0" bIns="0" anchor="t">
            <a:spAutoFit/>
          </a:bodyPr>
          <a:p>
            <a:pPr marL="39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esti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Freeform 62"/>
          <p:cNvSpPr/>
          <p:nvPr/>
        </p:nvSpPr>
        <p:spPr>
          <a:xfrm>
            <a:off x="7397640" y="5899320"/>
            <a:ext cx="69840" cy="152280"/>
          </a:xfrm>
          <a:custGeom>
            <a:avLst/>
            <a:gdLst>
              <a:gd name="textAreaLeft" fmla="*/ 0 w 69840"/>
              <a:gd name="textAreaRight" fmla="*/ 69840 w 69840"/>
              <a:gd name="textAreaTop" fmla="*/ 0 h 152280"/>
              <a:gd name="textAreaBottom" fmla="*/ 152640 h 1522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1929" y="0"/>
                  <a:pt x="21600" y="806"/>
                  <a:pt x="21600" y="1800"/>
                </a:cubicBezTo>
                <a:lnTo>
                  <a:pt x="21600" y="19800"/>
                </a:lnTo>
                <a:cubicBezTo>
                  <a:pt x="21600" y="20794"/>
                  <a:pt x="11929" y="21600"/>
                  <a:pt x="0" y="21600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Freeform 63"/>
          <p:cNvSpPr/>
          <p:nvPr/>
        </p:nvSpPr>
        <p:spPr>
          <a:xfrm>
            <a:off x="7391520" y="5378400"/>
            <a:ext cx="75960" cy="152280"/>
          </a:xfrm>
          <a:custGeom>
            <a:avLst/>
            <a:gdLst>
              <a:gd name="textAreaLeft" fmla="*/ 0 w 75960"/>
              <a:gd name="textAreaRight" fmla="*/ 76320 w 75960"/>
              <a:gd name="textAreaTop" fmla="*/ 0 h 152280"/>
              <a:gd name="textAreaBottom" fmla="*/ 152640 h 1522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1929" y="0"/>
                  <a:pt x="21600" y="806"/>
                  <a:pt x="21600" y="1800"/>
                </a:cubicBezTo>
                <a:lnTo>
                  <a:pt x="21600" y="19800"/>
                </a:lnTo>
                <a:cubicBezTo>
                  <a:pt x="21600" y="20794"/>
                  <a:pt x="11929" y="21600"/>
                  <a:pt x="0" y="21600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94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14T18:24:34Z</dcterms:created>
  <dc:creator>william held</dc:creator>
  <dc:description/>
  <dc:language>en-US</dc:language>
  <cp:lastModifiedBy>Hiroki</cp:lastModifiedBy>
  <cp:lastPrinted>2010-05-04T17:44:22Z</cp:lastPrinted>
  <dcterms:modified xsi:type="dcterms:W3CDTF">2011-05-06T13:48:18Z</dcterms:modified>
  <cp:revision>76</cp:revision>
  <dc:subject/>
  <dc:title>PowerPoint Presentation</dc:title>
</cp:coreProperties>
</file>